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  <p:sldId id="261" r:id="rId6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40" d="100"/>
          <a:sy n="40" d="100"/>
        </p:scale>
        <p:origin x="-1843" y="235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010B2-50BE-4CC0-8F61-874B431D087C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DFFB-E121-482A-81FA-EA72DB3841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1350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010B2-50BE-4CC0-8F61-874B431D087C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DFFB-E121-482A-81FA-EA72DB3841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567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010B2-50BE-4CC0-8F61-874B431D087C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DFFB-E121-482A-81FA-EA72DB3841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7333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010B2-50BE-4CC0-8F61-874B431D087C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DFFB-E121-482A-81FA-EA72DB3841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6772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010B2-50BE-4CC0-8F61-874B431D087C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DFFB-E121-482A-81FA-EA72DB3841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460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010B2-50BE-4CC0-8F61-874B431D087C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DFFB-E121-482A-81FA-EA72DB3841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2163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010B2-50BE-4CC0-8F61-874B431D087C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DFFB-E121-482A-81FA-EA72DB3841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3474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010B2-50BE-4CC0-8F61-874B431D087C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DFFB-E121-482A-81FA-EA72DB3841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40773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010B2-50BE-4CC0-8F61-874B431D087C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DFFB-E121-482A-81FA-EA72DB3841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75542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010B2-50BE-4CC0-8F61-874B431D087C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DFFB-E121-482A-81FA-EA72DB3841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9714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5010B2-50BE-4CC0-8F61-874B431D087C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7CDFFB-E121-482A-81FA-EA72DB3841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6183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5010B2-50BE-4CC0-8F61-874B431D087C}" type="datetimeFigureOut">
              <a:rPr lang="en-GB" smtClean="0"/>
              <a:t>09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CDFFB-E121-482A-81FA-EA72DB38410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8711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13886" y="1030509"/>
            <a:ext cx="6044666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b="1" dirty="0"/>
              <a:t>A novel model of heterogeneous hypoxia reveals an hypoxic-like response in normoxic cancer cells</a:t>
            </a:r>
            <a:endParaRPr lang="en-GB" sz="1400" dirty="0"/>
          </a:p>
          <a:p>
            <a:r>
              <a:rPr lang="en-GB" sz="1400" b="1" dirty="0"/>
              <a:t> </a:t>
            </a:r>
            <a:endParaRPr lang="en-GB" sz="1400" dirty="0"/>
          </a:p>
          <a:p>
            <a:r>
              <a:rPr lang="en-GB" sz="1400" dirty="0"/>
              <a:t>Hannah </a:t>
            </a:r>
            <a:r>
              <a:rPr lang="en-GB" sz="1400" dirty="0" smtClean="0"/>
              <a:t>Harrison, </a:t>
            </a:r>
            <a:r>
              <a:rPr lang="en-GB" sz="1400" dirty="0"/>
              <a:t>Henry Pegg, Jamie Thompson, Christian Bates and Paul </a:t>
            </a:r>
            <a:r>
              <a:rPr lang="en-GB" sz="1400" dirty="0" smtClean="0"/>
              <a:t>Shore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5903202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G:\Westerns\260216\LamforHIF (Chemi Hi Sensitivity)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5736" y="4509631"/>
            <a:ext cx="2496316" cy="8363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5" descr="G:\Westerns\260216\HIF (Chemi Hi Sensitivity)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2"/>
          <a:stretch/>
        </p:blipFill>
        <p:spPr bwMode="auto">
          <a:xfrm>
            <a:off x="1648276" y="2364598"/>
            <a:ext cx="2568153" cy="14543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 rot="16200000">
            <a:off x="1518339" y="1911092"/>
            <a:ext cx="11122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MCF7-parental</a:t>
            </a:r>
            <a:endParaRPr lang="en-GB" sz="1200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1812723" y="1607994"/>
            <a:ext cx="1715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MCF7-mHIF-YFP-DD [47]</a:t>
            </a:r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2403469" y="1612640"/>
            <a:ext cx="17155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MCF7-mHIF-YFP-DD [48]</a:t>
            </a:r>
            <a:endParaRPr lang="en-GB" sz="1200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3092420" y="1681846"/>
            <a:ext cx="1588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231-mHIF-YFP-DD [50]</a:t>
            </a:r>
            <a:endParaRPr lang="en-GB" sz="1200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1863787" y="2607950"/>
            <a:ext cx="42755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2440811" y="2609893"/>
            <a:ext cx="42755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3044262" y="2603885"/>
            <a:ext cx="42755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3653467" y="2609893"/>
            <a:ext cx="42755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851925" y="2948020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-   +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2397883" y="2948020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-   +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3014152" y="2948020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-   +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3605725" y="2948020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-   +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763668" y="3002650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10µM TMP</a:t>
            </a:r>
            <a:endParaRPr lang="en-GB" sz="1400" dirty="0"/>
          </a:p>
        </p:txBody>
      </p:sp>
      <p:sp>
        <p:nvSpPr>
          <p:cNvPr id="19" name="TextBox 18"/>
          <p:cNvSpPr txBox="1"/>
          <p:nvPr/>
        </p:nvSpPr>
        <p:spPr>
          <a:xfrm>
            <a:off x="4458165" y="3460559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HIF</a:t>
            </a:r>
            <a:endParaRPr lang="en-GB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4469460" y="4773932"/>
            <a:ext cx="8547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err="1" smtClean="0"/>
              <a:t>Lamin</a:t>
            </a:r>
            <a:r>
              <a:rPr lang="en-GB" sz="1400" dirty="0" smtClean="0"/>
              <a:t> B1</a:t>
            </a:r>
            <a:endParaRPr lang="en-GB" sz="1400" dirty="0"/>
          </a:p>
        </p:txBody>
      </p:sp>
      <p:sp>
        <p:nvSpPr>
          <p:cNvPr id="21" name="TextBox 20"/>
          <p:cNvSpPr txBox="1"/>
          <p:nvPr/>
        </p:nvSpPr>
        <p:spPr>
          <a:xfrm>
            <a:off x="606987" y="5745955"/>
            <a:ext cx="58611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200" b="1" u="sng" dirty="0" smtClean="0"/>
          </a:p>
          <a:p>
            <a:r>
              <a:rPr lang="en-GB" sz="1200" dirty="0" smtClean="0"/>
              <a:t>Western blot was cut in 2 halves with top being labelled for HIF and bottom for </a:t>
            </a:r>
            <a:r>
              <a:rPr lang="en-GB" sz="1200" dirty="0" err="1" smtClean="0"/>
              <a:t>Lamin</a:t>
            </a:r>
            <a:r>
              <a:rPr lang="en-GB" sz="1200" dirty="0" smtClean="0"/>
              <a:t> B1.</a:t>
            </a:r>
          </a:p>
          <a:p>
            <a:r>
              <a:rPr lang="en-GB" sz="1200" dirty="0" smtClean="0"/>
              <a:t>This unedited western shows MCF7 parental cells, 2 MCF7-mHIF clones (#47 and 48) and 1 231-mHIF clone (#50)</a:t>
            </a:r>
            <a:endParaRPr lang="en-GB" sz="1200" dirty="0"/>
          </a:p>
        </p:txBody>
      </p:sp>
      <p:sp>
        <p:nvSpPr>
          <p:cNvPr id="22" name="Rectangle 21"/>
          <p:cNvSpPr/>
          <p:nvPr/>
        </p:nvSpPr>
        <p:spPr>
          <a:xfrm>
            <a:off x="212637" y="205959"/>
            <a:ext cx="361393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Harrison</a:t>
            </a:r>
            <a:r>
              <a:rPr lang="en-GB" b="1" i="1" dirty="0" smtClean="0"/>
              <a:t>etal</a:t>
            </a:r>
            <a:r>
              <a:rPr lang="en-GB" b="1" dirty="0" smtClean="0"/>
              <a:t>_SupplementalFigure1</a:t>
            </a:r>
          </a:p>
        </p:txBody>
      </p:sp>
    </p:spTree>
    <p:extLst>
      <p:ext uri="{BB962C8B-B14F-4D97-AF65-F5344CB8AC3E}">
        <p14:creationId xmlns:p14="http://schemas.microsoft.com/office/powerpoint/2010/main" val="14377370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212637" y="205959"/>
            <a:ext cx="35081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Harrison</a:t>
            </a:r>
            <a:r>
              <a:rPr lang="en-GB" b="1" i="1" dirty="0" smtClean="0"/>
              <a:t>etal</a:t>
            </a:r>
            <a:r>
              <a:rPr lang="en-GB" b="1" dirty="0" smtClean="0"/>
              <a:t>_SupplementalFigure2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4987" y="1168167"/>
            <a:ext cx="5792787" cy="33607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2136810" y="136678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*</a:t>
            </a:r>
            <a:endParaRPr lang="en-GB" dirty="0"/>
          </a:p>
        </p:txBody>
      </p:sp>
      <p:sp>
        <p:nvSpPr>
          <p:cNvPr id="5" name="TextBox 4"/>
          <p:cNvSpPr txBox="1"/>
          <p:nvPr/>
        </p:nvSpPr>
        <p:spPr>
          <a:xfrm>
            <a:off x="4040960" y="303031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*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534987" y="4538203"/>
            <a:ext cx="58611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200" b="1" u="sng" dirty="0" smtClean="0"/>
          </a:p>
          <a:p>
            <a:r>
              <a:rPr lang="en-GB" sz="1200" dirty="0" smtClean="0"/>
              <a:t>The hypoxic effect of conditioned medium taken from MCF7 and MDA-MB-231 upon mammosphere formation is blocked by addition of the HIF1 inhibitor, YC-1, during conditioning. Represented as mean +/- SEM. * P&lt;0.05 from 21% control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5418837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833317" y="1234992"/>
            <a:ext cx="5396011" cy="1515505"/>
            <a:chOff x="2417456" y="603343"/>
            <a:chExt cx="5396011" cy="1515505"/>
          </a:xfrm>
        </p:grpSpPr>
        <p:grpSp>
          <p:nvGrpSpPr>
            <p:cNvPr id="3" name="Group 2"/>
            <p:cNvGrpSpPr/>
            <p:nvPr/>
          </p:nvGrpSpPr>
          <p:grpSpPr>
            <a:xfrm>
              <a:off x="6436348" y="1313365"/>
              <a:ext cx="132058" cy="80035"/>
              <a:chOff x="3761494" y="1856268"/>
              <a:chExt cx="132058" cy="80035"/>
            </a:xfrm>
          </p:grpSpPr>
          <p:sp>
            <p:nvSpPr>
              <p:cNvPr id="128" name="Chord 127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9" name="Oval 128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4" name="Round Same Side Corner Rectangle 3"/>
            <p:cNvSpPr/>
            <p:nvPr/>
          </p:nvSpPr>
          <p:spPr>
            <a:xfrm rot="10800000">
              <a:off x="5006964" y="1248511"/>
              <a:ext cx="1169043" cy="174376"/>
            </a:xfrm>
            <a:prstGeom prst="round2SameRect">
              <a:avLst>
                <a:gd name="adj1" fmla="val 42543"/>
                <a:gd name="adj2" fmla="val 0"/>
              </a:avLst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Round Same Side Corner Rectangle 4"/>
            <p:cNvSpPr/>
            <p:nvPr/>
          </p:nvSpPr>
          <p:spPr>
            <a:xfrm rot="10800000">
              <a:off x="4995154" y="1102290"/>
              <a:ext cx="1191637" cy="304856"/>
            </a:xfrm>
            <a:prstGeom prst="round2Same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5188586" y="1341342"/>
              <a:ext cx="132058" cy="80035"/>
              <a:chOff x="3761494" y="1856268"/>
              <a:chExt cx="132058" cy="80035"/>
            </a:xfrm>
          </p:grpSpPr>
          <p:sp>
            <p:nvSpPr>
              <p:cNvPr id="126" name="Chord 125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7" name="Oval 126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5322977" y="1341666"/>
              <a:ext cx="132058" cy="80035"/>
              <a:chOff x="3761494" y="1856268"/>
              <a:chExt cx="132058" cy="80035"/>
            </a:xfrm>
          </p:grpSpPr>
          <p:sp>
            <p:nvSpPr>
              <p:cNvPr id="124" name="Chord 123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5" name="Oval 124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5450882" y="1341666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122" name="Chord 121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3" name="Oval 122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5582940" y="1341666"/>
              <a:ext cx="132058" cy="80035"/>
              <a:chOff x="3761494" y="1856268"/>
              <a:chExt cx="132058" cy="80035"/>
            </a:xfrm>
          </p:grpSpPr>
          <p:sp>
            <p:nvSpPr>
              <p:cNvPr id="120" name="Chord 119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1" name="Oval 120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5700103" y="1337617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118" name="Chord 117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9" name="Oval 118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5831908" y="1337617"/>
              <a:ext cx="132058" cy="80035"/>
              <a:chOff x="3761494" y="1856268"/>
              <a:chExt cx="132058" cy="80035"/>
            </a:xfrm>
          </p:grpSpPr>
          <p:sp>
            <p:nvSpPr>
              <p:cNvPr id="116" name="Chord 115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7" name="Oval 116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5965760" y="1337617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114" name="Chord 113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5" name="Oval 114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6436348" y="1149094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112" name="Chord 111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3" name="Oval 112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4" name="TextBox 13"/>
            <p:cNvSpPr txBox="1"/>
            <p:nvPr/>
          </p:nvSpPr>
          <p:spPr>
            <a:xfrm>
              <a:off x="6546774" y="1039274"/>
              <a:ext cx="1266693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/>
                <a:t>Parental cell</a:t>
              </a:r>
            </a:p>
            <a:p>
              <a:r>
                <a:rPr lang="en-GB" sz="1100" dirty="0"/>
                <a:t>Inducible </a:t>
              </a:r>
              <a:r>
                <a:rPr lang="en-GB" sz="1100" dirty="0" err="1"/>
                <a:t>mHIF</a:t>
              </a:r>
              <a:r>
                <a:rPr lang="en-GB" sz="1100" dirty="0"/>
                <a:t> </a:t>
              </a:r>
              <a:r>
                <a:rPr lang="en-GB" sz="1100" dirty="0" smtClean="0"/>
                <a:t>cell</a:t>
              </a:r>
            </a:p>
          </p:txBody>
        </p:sp>
        <p:grpSp>
          <p:nvGrpSpPr>
            <p:cNvPr id="15" name="Group 14"/>
            <p:cNvGrpSpPr/>
            <p:nvPr/>
          </p:nvGrpSpPr>
          <p:grpSpPr>
            <a:xfrm>
              <a:off x="5064884" y="1340238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110" name="Chord 109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1" name="Oval 110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6" name="Round Same Side Corner Rectangle 15"/>
            <p:cNvSpPr/>
            <p:nvPr/>
          </p:nvSpPr>
          <p:spPr>
            <a:xfrm rot="10800000">
              <a:off x="2437812" y="1257277"/>
              <a:ext cx="1169043" cy="174376"/>
            </a:xfrm>
            <a:prstGeom prst="round2SameRect">
              <a:avLst>
                <a:gd name="adj1" fmla="val 42543"/>
                <a:gd name="adj2" fmla="val 0"/>
              </a:avLst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Round Same Side Corner Rectangle 16"/>
            <p:cNvSpPr/>
            <p:nvPr/>
          </p:nvSpPr>
          <p:spPr>
            <a:xfrm rot="10800000">
              <a:off x="2417456" y="1111056"/>
              <a:ext cx="1191637" cy="304856"/>
            </a:xfrm>
            <a:prstGeom prst="round2Same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18" name="Group 17"/>
            <p:cNvGrpSpPr/>
            <p:nvPr/>
          </p:nvGrpSpPr>
          <p:grpSpPr>
            <a:xfrm>
              <a:off x="2873184" y="1350432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108" name="Chord 107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9" name="Oval 108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3122405" y="1346383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106" name="Chord 105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7" name="Oval 106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3388062" y="1346383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104" name="Chord 103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5" name="Oval 104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2487186" y="1349004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102" name="Chord 101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3" name="Oval 102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2" name="Round Same Side Corner Rectangle 21"/>
            <p:cNvSpPr/>
            <p:nvPr/>
          </p:nvSpPr>
          <p:spPr>
            <a:xfrm rot="10800000">
              <a:off x="3725624" y="1248511"/>
              <a:ext cx="1169043" cy="174376"/>
            </a:xfrm>
            <a:prstGeom prst="round2SameRect">
              <a:avLst>
                <a:gd name="adj1" fmla="val 42543"/>
                <a:gd name="adj2" fmla="val 0"/>
              </a:avLst>
            </a:prstGeom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Round Same Side Corner Rectangle 22"/>
            <p:cNvSpPr/>
            <p:nvPr/>
          </p:nvSpPr>
          <p:spPr>
            <a:xfrm rot="10800000">
              <a:off x="3713814" y="1102290"/>
              <a:ext cx="1191637" cy="304856"/>
            </a:xfrm>
            <a:prstGeom prst="round2Same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24" name="Group 23"/>
            <p:cNvGrpSpPr/>
            <p:nvPr/>
          </p:nvGrpSpPr>
          <p:grpSpPr>
            <a:xfrm>
              <a:off x="3907246" y="1341342"/>
              <a:ext cx="132058" cy="80035"/>
              <a:chOff x="3761494" y="1856268"/>
              <a:chExt cx="132058" cy="80035"/>
            </a:xfrm>
          </p:grpSpPr>
          <p:sp>
            <p:nvSpPr>
              <p:cNvPr id="100" name="Chord 99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1" name="Oval 100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5" name="Group 24"/>
            <p:cNvGrpSpPr/>
            <p:nvPr/>
          </p:nvGrpSpPr>
          <p:grpSpPr>
            <a:xfrm>
              <a:off x="4041637" y="1341666"/>
              <a:ext cx="132058" cy="80035"/>
              <a:chOff x="3761494" y="1856268"/>
              <a:chExt cx="132058" cy="80035"/>
            </a:xfrm>
          </p:grpSpPr>
          <p:sp>
            <p:nvSpPr>
              <p:cNvPr id="98" name="Chord 97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9" name="Oval 98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6" name="Group 25"/>
            <p:cNvGrpSpPr/>
            <p:nvPr/>
          </p:nvGrpSpPr>
          <p:grpSpPr>
            <a:xfrm>
              <a:off x="4301600" y="1341666"/>
              <a:ext cx="132058" cy="80035"/>
              <a:chOff x="3761494" y="1856268"/>
              <a:chExt cx="132058" cy="80035"/>
            </a:xfrm>
          </p:grpSpPr>
          <p:sp>
            <p:nvSpPr>
              <p:cNvPr id="96" name="Chord 95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7" name="Oval 96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7" name="Group 26"/>
            <p:cNvGrpSpPr/>
            <p:nvPr/>
          </p:nvGrpSpPr>
          <p:grpSpPr>
            <a:xfrm>
              <a:off x="4550568" y="1337617"/>
              <a:ext cx="132058" cy="80035"/>
              <a:chOff x="3761494" y="1856268"/>
              <a:chExt cx="132058" cy="80035"/>
            </a:xfrm>
          </p:grpSpPr>
          <p:sp>
            <p:nvSpPr>
              <p:cNvPr id="94" name="Chord 93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5" name="Oval 94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8" name="Group 27"/>
            <p:cNvGrpSpPr/>
            <p:nvPr/>
          </p:nvGrpSpPr>
          <p:grpSpPr>
            <a:xfrm>
              <a:off x="4170744" y="1339914"/>
              <a:ext cx="132058" cy="80035"/>
              <a:chOff x="3761494" y="1856268"/>
              <a:chExt cx="132058" cy="80035"/>
            </a:xfrm>
          </p:grpSpPr>
          <p:sp>
            <p:nvSpPr>
              <p:cNvPr id="92" name="Chord 91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3" name="Oval 92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4424779" y="1340238"/>
              <a:ext cx="132058" cy="80035"/>
              <a:chOff x="3761494" y="1856268"/>
              <a:chExt cx="132058" cy="80035"/>
            </a:xfrm>
          </p:grpSpPr>
          <p:sp>
            <p:nvSpPr>
              <p:cNvPr id="90" name="Chord 89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1" name="Oval 90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4676196" y="1340238"/>
              <a:ext cx="132058" cy="80035"/>
              <a:chOff x="3761494" y="1856268"/>
              <a:chExt cx="132058" cy="80035"/>
            </a:xfrm>
          </p:grpSpPr>
          <p:sp>
            <p:nvSpPr>
              <p:cNvPr id="88" name="Chord 87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9" name="Oval 88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31" name="Group 30"/>
            <p:cNvGrpSpPr/>
            <p:nvPr/>
          </p:nvGrpSpPr>
          <p:grpSpPr>
            <a:xfrm>
              <a:off x="2743535" y="1348549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86" name="Chord 85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7" name="Oval 86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32" name="Group 31"/>
            <p:cNvGrpSpPr/>
            <p:nvPr/>
          </p:nvGrpSpPr>
          <p:grpSpPr>
            <a:xfrm>
              <a:off x="2992756" y="1344500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84" name="Chord 83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5" name="Oval 84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33" name="Group 32"/>
            <p:cNvGrpSpPr/>
            <p:nvPr/>
          </p:nvGrpSpPr>
          <p:grpSpPr>
            <a:xfrm>
              <a:off x="3258413" y="1344500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82" name="Chord 81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3" name="Oval 82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34" name="Group 33"/>
            <p:cNvGrpSpPr/>
            <p:nvPr/>
          </p:nvGrpSpPr>
          <p:grpSpPr>
            <a:xfrm>
              <a:off x="2613917" y="1347121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80" name="Chord 79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1" name="Oval 80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2962432" y="1849160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78" name="Chord 77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9" name="Oval 78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3114832" y="1967376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76" name="Chord 75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7" name="Oval 76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37" name="Group 36"/>
            <p:cNvGrpSpPr/>
            <p:nvPr/>
          </p:nvGrpSpPr>
          <p:grpSpPr>
            <a:xfrm>
              <a:off x="2942484" y="2021062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74" name="Chord 73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5" name="Oval 74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38" name="Group 37"/>
            <p:cNvGrpSpPr/>
            <p:nvPr/>
          </p:nvGrpSpPr>
          <p:grpSpPr>
            <a:xfrm>
              <a:off x="4270951" y="1849160"/>
              <a:ext cx="132058" cy="80035"/>
              <a:chOff x="3761494" y="1856268"/>
              <a:chExt cx="132058" cy="80035"/>
            </a:xfrm>
          </p:grpSpPr>
          <p:sp>
            <p:nvSpPr>
              <p:cNvPr id="72" name="Chord 71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3" name="Oval 72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39" name="Group 38"/>
            <p:cNvGrpSpPr/>
            <p:nvPr/>
          </p:nvGrpSpPr>
          <p:grpSpPr>
            <a:xfrm>
              <a:off x="4423351" y="1967376"/>
              <a:ext cx="132058" cy="80035"/>
              <a:chOff x="3761494" y="1856268"/>
              <a:chExt cx="132058" cy="80035"/>
            </a:xfrm>
          </p:grpSpPr>
          <p:sp>
            <p:nvSpPr>
              <p:cNvPr id="70" name="Chord 69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1" name="Oval 70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40" name="Group 39"/>
            <p:cNvGrpSpPr/>
            <p:nvPr/>
          </p:nvGrpSpPr>
          <p:grpSpPr>
            <a:xfrm>
              <a:off x="4225365" y="2021062"/>
              <a:ext cx="132058" cy="80035"/>
              <a:chOff x="3761494" y="1856268"/>
              <a:chExt cx="132058" cy="80035"/>
            </a:xfrm>
          </p:grpSpPr>
          <p:sp>
            <p:nvSpPr>
              <p:cNvPr id="68" name="Chord 67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9" name="Oval 68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cxnSp>
          <p:nvCxnSpPr>
            <p:cNvPr id="41" name="Straight Arrow Connector 40"/>
            <p:cNvCxnSpPr/>
            <p:nvPr/>
          </p:nvCxnSpPr>
          <p:spPr>
            <a:xfrm flipH="1">
              <a:off x="3013274" y="1463519"/>
              <a:ext cx="1448" cy="32567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 flipH="1">
              <a:off x="4315138" y="1463519"/>
              <a:ext cx="1448" cy="32567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 flipH="1">
              <a:off x="5330124" y="1463519"/>
              <a:ext cx="1448" cy="32567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 flipH="1">
              <a:off x="5887134" y="1463519"/>
              <a:ext cx="1448" cy="32567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2417456" y="922946"/>
              <a:ext cx="2477211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/>
            <p:cNvSpPr txBox="1"/>
            <p:nvPr/>
          </p:nvSpPr>
          <p:spPr>
            <a:xfrm>
              <a:off x="2437812" y="606750"/>
              <a:ext cx="245685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 smtClean="0"/>
                <a:t>Mono-culture</a:t>
              </a:r>
              <a:endParaRPr lang="en-GB" dirty="0"/>
            </a:p>
          </p:txBody>
        </p:sp>
        <p:cxnSp>
          <p:nvCxnSpPr>
            <p:cNvPr id="47" name="Straight Connector 46"/>
            <p:cNvCxnSpPr/>
            <p:nvPr/>
          </p:nvCxnSpPr>
          <p:spPr>
            <a:xfrm>
              <a:off x="4978499" y="919539"/>
              <a:ext cx="1238400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/>
            <p:cNvSpPr txBox="1"/>
            <p:nvPr/>
          </p:nvSpPr>
          <p:spPr>
            <a:xfrm>
              <a:off x="4998855" y="603343"/>
              <a:ext cx="12182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 smtClean="0"/>
                <a:t>Co-culture</a:t>
              </a:r>
              <a:endParaRPr lang="en-GB" dirty="0"/>
            </a:p>
          </p:txBody>
        </p:sp>
        <p:grpSp>
          <p:nvGrpSpPr>
            <p:cNvPr id="49" name="Group 48"/>
            <p:cNvGrpSpPr/>
            <p:nvPr/>
          </p:nvGrpSpPr>
          <p:grpSpPr>
            <a:xfrm>
              <a:off x="5276895" y="1866911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66" name="Chord 65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7" name="Oval 66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0" name="Group 49"/>
            <p:cNvGrpSpPr/>
            <p:nvPr/>
          </p:nvGrpSpPr>
          <p:grpSpPr>
            <a:xfrm>
              <a:off x="5429295" y="1985127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64" name="Chord 63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5" name="Oval 64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1" name="Group 50"/>
            <p:cNvGrpSpPr/>
            <p:nvPr/>
          </p:nvGrpSpPr>
          <p:grpSpPr>
            <a:xfrm>
              <a:off x="5256947" y="2038813"/>
              <a:ext cx="132058" cy="80035"/>
              <a:chOff x="3761494" y="1856268"/>
              <a:chExt cx="132058" cy="80035"/>
            </a:xfrm>
            <a:solidFill>
              <a:schemeClr val="accent5">
                <a:lumMod val="20000"/>
                <a:lumOff val="80000"/>
              </a:schemeClr>
            </a:solidFill>
          </p:grpSpPr>
          <p:sp>
            <p:nvSpPr>
              <p:cNvPr id="62" name="Chord 61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3" name="Oval 62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grp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2" name="Group 51"/>
            <p:cNvGrpSpPr/>
            <p:nvPr/>
          </p:nvGrpSpPr>
          <p:grpSpPr>
            <a:xfrm>
              <a:off x="5841912" y="1866911"/>
              <a:ext cx="132058" cy="80035"/>
              <a:chOff x="3761494" y="1856268"/>
              <a:chExt cx="132058" cy="80035"/>
            </a:xfrm>
          </p:grpSpPr>
          <p:sp>
            <p:nvSpPr>
              <p:cNvPr id="60" name="Chord 59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1" name="Oval 60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3" name="Group 52"/>
            <p:cNvGrpSpPr/>
            <p:nvPr/>
          </p:nvGrpSpPr>
          <p:grpSpPr>
            <a:xfrm>
              <a:off x="5994312" y="1985127"/>
              <a:ext cx="132058" cy="80035"/>
              <a:chOff x="3761494" y="1856268"/>
              <a:chExt cx="132058" cy="80035"/>
            </a:xfrm>
          </p:grpSpPr>
          <p:sp>
            <p:nvSpPr>
              <p:cNvPr id="58" name="Chord 57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9" name="Oval 58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54" name="Group 53"/>
            <p:cNvGrpSpPr/>
            <p:nvPr/>
          </p:nvGrpSpPr>
          <p:grpSpPr>
            <a:xfrm>
              <a:off x="5796326" y="2038813"/>
              <a:ext cx="132058" cy="80035"/>
              <a:chOff x="3761494" y="1856268"/>
              <a:chExt cx="132058" cy="80035"/>
            </a:xfrm>
          </p:grpSpPr>
          <p:sp>
            <p:nvSpPr>
              <p:cNvPr id="56" name="Chord 55"/>
              <p:cNvSpPr/>
              <p:nvPr/>
            </p:nvSpPr>
            <p:spPr>
              <a:xfrm rot="6550325">
                <a:off x="3787505" y="1830257"/>
                <a:ext cx="80035" cy="132058"/>
              </a:xfrm>
              <a:prstGeom prst="chord">
                <a:avLst/>
              </a:prstGeom>
              <a:solidFill>
                <a:srgbClr val="92D050"/>
              </a:solidFill>
              <a:ln w="12700">
                <a:solidFill>
                  <a:schemeClr val="accent3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7" name="Oval 56"/>
              <p:cNvSpPr>
                <a:spLocks noChangeAspect="1"/>
              </p:cNvSpPr>
              <p:nvPr/>
            </p:nvSpPr>
            <p:spPr>
              <a:xfrm>
                <a:off x="3788581" y="1863886"/>
                <a:ext cx="32400" cy="32400"/>
              </a:xfrm>
              <a:prstGeom prst="ellipse">
                <a:avLst/>
              </a:prstGeom>
              <a:solidFill>
                <a:schemeClr val="accent3">
                  <a:lumMod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55" name="TextBox 54"/>
            <p:cNvSpPr txBox="1"/>
            <p:nvPr/>
          </p:nvSpPr>
          <p:spPr>
            <a:xfrm>
              <a:off x="5006961" y="1387259"/>
              <a:ext cx="121824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dirty="0" smtClean="0"/>
                <a:t>FACS</a:t>
              </a:r>
              <a:endParaRPr lang="en-GB" dirty="0"/>
            </a:p>
          </p:txBody>
        </p:sp>
      </p:grpSp>
      <p:sp>
        <p:nvSpPr>
          <p:cNvPr id="130" name="Rectangle 129"/>
          <p:cNvSpPr/>
          <p:nvPr/>
        </p:nvSpPr>
        <p:spPr>
          <a:xfrm>
            <a:off x="212637" y="205959"/>
            <a:ext cx="35081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Harrison</a:t>
            </a:r>
            <a:r>
              <a:rPr lang="en-GB" b="1" i="1" dirty="0" smtClean="0"/>
              <a:t>etal</a:t>
            </a:r>
            <a:r>
              <a:rPr lang="en-GB" b="1" dirty="0" smtClean="0"/>
              <a:t>_SupplementalFigure3</a:t>
            </a:r>
          </a:p>
        </p:txBody>
      </p:sp>
      <p:sp>
        <p:nvSpPr>
          <p:cNvPr id="131" name="TextBox 130"/>
          <p:cNvSpPr txBox="1"/>
          <p:nvPr/>
        </p:nvSpPr>
        <p:spPr>
          <a:xfrm>
            <a:off x="484121" y="3219542"/>
            <a:ext cx="586119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200" b="1" u="sng" dirty="0" smtClean="0"/>
          </a:p>
          <a:p>
            <a:r>
              <a:rPr lang="en-GB" sz="1200" dirty="0" smtClean="0"/>
              <a:t>Schematic showing co-culture. Parental and inducible cells were grown either in mono-culture or as co-culture for 48 hours. The co-culture was then separated by FACS into GFP +</a:t>
            </a:r>
            <a:r>
              <a:rPr lang="en-GB" sz="1200" dirty="0" err="1" smtClean="0"/>
              <a:t>ve</a:t>
            </a:r>
            <a:r>
              <a:rPr lang="en-GB" sz="1200" dirty="0" smtClean="0"/>
              <a:t> and –</a:t>
            </a:r>
            <a:r>
              <a:rPr lang="en-GB" sz="1200" dirty="0" err="1" smtClean="0"/>
              <a:t>ve</a:t>
            </a:r>
            <a:r>
              <a:rPr lang="en-GB" sz="1200" dirty="0" smtClean="0"/>
              <a:t> populations. Mono-cultures were also exposed to FACS as a control for pressure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008670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0"/>
            <a:ext cx="28196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Harrison</a:t>
            </a:r>
            <a:r>
              <a:rPr lang="en-GB" sz="1400" b="1" i="1" dirty="0" smtClean="0"/>
              <a:t>etal</a:t>
            </a:r>
            <a:r>
              <a:rPr lang="en-GB" sz="1400" b="1" dirty="0" smtClean="0"/>
              <a:t>_SupplementalFigure4 </a:t>
            </a:r>
            <a:endParaRPr lang="en-GB" sz="1400" dirty="0" smtClean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39" r="34598"/>
          <a:stretch/>
        </p:blipFill>
        <p:spPr>
          <a:xfrm>
            <a:off x="975360" y="1911198"/>
            <a:ext cx="1493520" cy="2236275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 rot="16200000">
            <a:off x="673821" y="1720617"/>
            <a:ext cx="11022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Marker Lane</a:t>
            </a:r>
            <a:endParaRPr lang="en-GB" sz="1400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945586" y="1785344"/>
            <a:ext cx="9877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1% Oxygen</a:t>
            </a:r>
            <a:endParaRPr lang="en-GB" sz="1400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1165370" y="1734118"/>
            <a:ext cx="10791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21% Oxygen</a:t>
            </a:r>
            <a:endParaRPr lang="en-GB" sz="1400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1476526" y="1785344"/>
            <a:ext cx="9877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1% Oxygen</a:t>
            </a:r>
            <a:endParaRPr lang="en-GB" sz="140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1696310" y="1734118"/>
            <a:ext cx="10791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21% Oxygen</a:t>
            </a:r>
            <a:endParaRPr lang="en-GB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1288704" y="1029699"/>
            <a:ext cx="6078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MCF7</a:t>
            </a:r>
            <a:endParaRPr lang="en-GB" sz="1400" dirty="0"/>
          </a:p>
        </p:txBody>
      </p:sp>
      <p:sp>
        <p:nvSpPr>
          <p:cNvPr id="13" name="TextBox 12"/>
          <p:cNvSpPr txBox="1"/>
          <p:nvPr/>
        </p:nvSpPr>
        <p:spPr>
          <a:xfrm>
            <a:off x="1884877" y="1029699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231</a:t>
            </a:r>
            <a:endParaRPr lang="en-GB" sz="1400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1371852" y="1341235"/>
            <a:ext cx="4418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882109" y="1341235"/>
            <a:ext cx="4418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207124" y="2408338"/>
            <a:ext cx="9076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100 </a:t>
            </a:r>
            <a:r>
              <a:rPr lang="en-GB" sz="1400" dirty="0" err="1" smtClean="0"/>
              <a:t>kDa</a:t>
            </a:r>
            <a:r>
              <a:rPr lang="en-GB" sz="1400" dirty="0" smtClean="0"/>
              <a:t> &gt;</a:t>
            </a:r>
            <a:endParaRPr lang="en-GB" sz="1400" dirty="0"/>
          </a:p>
        </p:txBody>
      </p:sp>
      <p:sp>
        <p:nvSpPr>
          <p:cNvPr id="17" name="TextBox 16"/>
          <p:cNvSpPr txBox="1"/>
          <p:nvPr/>
        </p:nvSpPr>
        <p:spPr>
          <a:xfrm>
            <a:off x="295749" y="2710697"/>
            <a:ext cx="8162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75 </a:t>
            </a:r>
            <a:r>
              <a:rPr lang="en-GB" sz="1400" dirty="0" err="1" smtClean="0"/>
              <a:t>kDa</a:t>
            </a:r>
            <a:r>
              <a:rPr lang="en-GB" sz="1400" dirty="0" smtClean="0"/>
              <a:t> &gt;</a:t>
            </a:r>
            <a:endParaRPr lang="en-GB" sz="1400" dirty="0"/>
          </a:p>
        </p:txBody>
      </p:sp>
      <p:sp>
        <p:nvSpPr>
          <p:cNvPr id="18" name="TextBox 17"/>
          <p:cNvSpPr txBox="1"/>
          <p:nvPr/>
        </p:nvSpPr>
        <p:spPr>
          <a:xfrm>
            <a:off x="295749" y="2991021"/>
            <a:ext cx="8162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50 </a:t>
            </a:r>
            <a:r>
              <a:rPr lang="en-GB" sz="1400" dirty="0" err="1" smtClean="0"/>
              <a:t>kDa</a:t>
            </a:r>
            <a:r>
              <a:rPr lang="en-GB" sz="1400" dirty="0" smtClean="0"/>
              <a:t> &gt;</a:t>
            </a:r>
            <a:endParaRPr lang="en-GB" sz="1400" dirty="0"/>
          </a:p>
        </p:txBody>
      </p:sp>
      <p:sp>
        <p:nvSpPr>
          <p:cNvPr id="19" name="TextBox 18"/>
          <p:cNvSpPr txBox="1"/>
          <p:nvPr/>
        </p:nvSpPr>
        <p:spPr>
          <a:xfrm>
            <a:off x="295749" y="3153829"/>
            <a:ext cx="8162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25 </a:t>
            </a:r>
            <a:r>
              <a:rPr lang="en-GB" sz="1400" dirty="0" err="1" smtClean="0"/>
              <a:t>kDa</a:t>
            </a:r>
            <a:r>
              <a:rPr lang="en-GB" sz="1400" dirty="0" smtClean="0"/>
              <a:t> &gt;</a:t>
            </a:r>
            <a:endParaRPr lang="en-GB" sz="1400" dirty="0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96" r="50716" b="37387"/>
          <a:stretch/>
        </p:blipFill>
        <p:spPr>
          <a:xfrm>
            <a:off x="3566159" y="2178628"/>
            <a:ext cx="1432561" cy="2326464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 rot="16200000">
            <a:off x="3249525" y="1720617"/>
            <a:ext cx="110222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Marker Lane</a:t>
            </a:r>
            <a:endParaRPr lang="en-GB" sz="1400" dirty="0"/>
          </a:p>
        </p:txBody>
      </p:sp>
      <p:sp>
        <p:nvSpPr>
          <p:cNvPr id="23" name="TextBox 22"/>
          <p:cNvSpPr txBox="1"/>
          <p:nvPr/>
        </p:nvSpPr>
        <p:spPr>
          <a:xfrm rot="16200000">
            <a:off x="3521289" y="1785344"/>
            <a:ext cx="9877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1% Oxygen</a:t>
            </a:r>
            <a:endParaRPr lang="en-GB" sz="14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3741074" y="1734118"/>
            <a:ext cx="10791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21% Oxygen</a:t>
            </a:r>
            <a:endParaRPr lang="en-GB" sz="14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4052229" y="1785344"/>
            <a:ext cx="9877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1% Oxygen</a:t>
            </a:r>
            <a:endParaRPr lang="en-GB" sz="1400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4272014" y="1734118"/>
            <a:ext cx="10791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21% Oxygen</a:t>
            </a:r>
            <a:endParaRPr lang="en-GB" sz="1400" dirty="0"/>
          </a:p>
        </p:txBody>
      </p:sp>
      <p:sp>
        <p:nvSpPr>
          <p:cNvPr id="27" name="TextBox 26"/>
          <p:cNvSpPr txBox="1"/>
          <p:nvPr/>
        </p:nvSpPr>
        <p:spPr>
          <a:xfrm>
            <a:off x="3874135" y="1029699"/>
            <a:ext cx="6078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MCF7</a:t>
            </a:r>
            <a:endParaRPr lang="en-GB" sz="1400" dirty="0"/>
          </a:p>
        </p:txBody>
      </p:sp>
      <p:sp>
        <p:nvSpPr>
          <p:cNvPr id="28" name="TextBox 27"/>
          <p:cNvSpPr txBox="1"/>
          <p:nvPr/>
        </p:nvSpPr>
        <p:spPr>
          <a:xfrm>
            <a:off x="4460581" y="1029699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231</a:t>
            </a:r>
            <a:endParaRPr lang="en-GB" sz="1400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3947555" y="1341235"/>
            <a:ext cx="4418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4457813" y="1341235"/>
            <a:ext cx="4418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1388847" y="3523328"/>
            <a:ext cx="6014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HIF1a</a:t>
            </a:r>
            <a:endParaRPr lang="en-GB" sz="1400" dirty="0"/>
          </a:p>
        </p:txBody>
      </p:sp>
      <p:sp>
        <p:nvSpPr>
          <p:cNvPr id="37" name="TextBox 36"/>
          <p:cNvSpPr txBox="1"/>
          <p:nvPr/>
        </p:nvSpPr>
        <p:spPr>
          <a:xfrm>
            <a:off x="3948368" y="3523328"/>
            <a:ext cx="723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Tubulin</a:t>
            </a:r>
            <a:endParaRPr lang="en-GB" sz="1400" dirty="0"/>
          </a:p>
        </p:txBody>
      </p:sp>
      <p:sp>
        <p:nvSpPr>
          <p:cNvPr id="38" name="TextBox 37"/>
          <p:cNvSpPr txBox="1"/>
          <p:nvPr/>
        </p:nvSpPr>
        <p:spPr>
          <a:xfrm>
            <a:off x="190625" y="7823487"/>
            <a:ext cx="642449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upplemental Figure 4: HIF activation by hypoxic and mimetic culture.</a:t>
            </a:r>
          </a:p>
          <a:p>
            <a:r>
              <a:rPr lang="en-GB" sz="1200" b="1" dirty="0" smtClean="0"/>
              <a:t>A.</a:t>
            </a:r>
            <a:r>
              <a:rPr lang="en-GB" sz="1200" dirty="0" smtClean="0"/>
              <a:t> Western blot was first labelled for HIF (Left), then washed and re-blotted for Tubulin (right). </a:t>
            </a:r>
          </a:p>
          <a:p>
            <a:r>
              <a:rPr lang="en-GB" sz="1200" dirty="0" smtClean="0"/>
              <a:t>This unedited western shows MCF7 and MDA-MB-231 parental cells cultured in 21% and 1% oxygen for 48 hours before lysis. </a:t>
            </a:r>
          </a:p>
          <a:p>
            <a:r>
              <a:rPr lang="en-GB" sz="1200" b="1" dirty="0" smtClean="0"/>
              <a:t>B.</a:t>
            </a:r>
            <a:r>
              <a:rPr lang="en-GB" sz="1200" dirty="0" smtClean="0"/>
              <a:t> Western blot was cut at approximately 80kDa and the top was labelled for HIF1 whilst the bottom was labelled for Tubulin. This unedited western shows MCF7 and MDA-MB-231 parental cells exposed to varying concentrations of CoCl</a:t>
            </a:r>
            <a:r>
              <a:rPr lang="en-GB" sz="1200" baseline="-25000" dirty="0" smtClean="0"/>
              <a:t>2</a:t>
            </a:r>
            <a:r>
              <a:rPr lang="en-GB" sz="1200" dirty="0" smtClean="0"/>
              <a:t>.</a:t>
            </a:r>
            <a:endParaRPr lang="en-GB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109538" y="866775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A</a:t>
            </a:r>
            <a:endParaRPr lang="en-GB" sz="1400" dirty="0" smtClean="0"/>
          </a:p>
        </p:txBody>
      </p:sp>
      <p:sp>
        <p:nvSpPr>
          <p:cNvPr id="41" name="TextBox 40"/>
          <p:cNvSpPr txBox="1"/>
          <p:nvPr/>
        </p:nvSpPr>
        <p:spPr>
          <a:xfrm>
            <a:off x="109538" y="454818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B</a:t>
            </a:r>
            <a:endParaRPr lang="en-GB" sz="1400" dirty="0" smtClean="0"/>
          </a:p>
        </p:txBody>
      </p:sp>
      <p:pic>
        <p:nvPicPr>
          <p:cNvPr id="42" name="Picture 4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4130" y="5526776"/>
            <a:ext cx="4534590" cy="1520445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 rot="16200000">
            <a:off x="1592649" y="5160896"/>
            <a:ext cx="632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µM</a:t>
            </a:r>
            <a:endParaRPr lang="en-GB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1914190" y="5098867"/>
            <a:ext cx="756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</a:t>
            </a:r>
            <a:r>
              <a:rPr lang="en-GB" dirty="0" smtClean="0"/>
              <a:t>0µM</a:t>
            </a:r>
            <a:endParaRPr lang="en-GB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2247940" y="5039285"/>
            <a:ext cx="875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µM</a:t>
            </a:r>
            <a:endParaRPr lang="en-GB" dirty="0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2596854" y="5039285"/>
            <a:ext cx="875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50µM</a:t>
            </a:r>
            <a:endParaRPr lang="en-GB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3501117" y="5160896"/>
            <a:ext cx="6320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µM</a:t>
            </a:r>
            <a:endParaRPr lang="en-GB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3794082" y="5098867"/>
            <a:ext cx="756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5</a:t>
            </a:r>
            <a:r>
              <a:rPr lang="en-GB" dirty="0" smtClean="0"/>
              <a:t>0µM</a:t>
            </a:r>
            <a:endParaRPr lang="en-GB" dirty="0"/>
          </a:p>
        </p:txBody>
      </p:sp>
      <p:sp>
        <p:nvSpPr>
          <p:cNvPr id="49" name="TextBox 48"/>
          <p:cNvSpPr txBox="1"/>
          <p:nvPr/>
        </p:nvSpPr>
        <p:spPr>
          <a:xfrm rot="16200000">
            <a:off x="4070680" y="5039285"/>
            <a:ext cx="875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µM</a:t>
            </a:r>
            <a:endParaRPr lang="en-GB" dirty="0"/>
          </a:p>
        </p:txBody>
      </p:sp>
      <p:sp>
        <p:nvSpPr>
          <p:cNvPr id="50" name="TextBox 49"/>
          <p:cNvSpPr txBox="1"/>
          <p:nvPr/>
        </p:nvSpPr>
        <p:spPr>
          <a:xfrm rot="16200000">
            <a:off x="4476746" y="5039285"/>
            <a:ext cx="8752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50µM</a:t>
            </a:r>
            <a:endParaRPr lang="en-GB" dirty="0"/>
          </a:p>
        </p:txBody>
      </p:sp>
      <p:sp>
        <p:nvSpPr>
          <p:cNvPr id="51" name="TextBox 50"/>
          <p:cNvSpPr txBox="1"/>
          <p:nvPr/>
        </p:nvSpPr>
        <p:spPr>
          <a:xfrm>
            <a:off x="265058" y="5843653"/>
            <a:ext cx="489366" cy="128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100 </a:t>
            </a:r>
            <a:r>
              <a:rPr lang="en-GB" sz="1400" dirty="0" err="1" smtClean="0"/>
              <a:t>kDa</a:t>
            </a:r>
            <a:r>
              <a:rPr lang="en-GB" sz="1400" dirty="0" smtClean="0"/>
              <a:t> &gt;</a:t>
            </a:r>
            <a:endParaRPr lang="en-GB" sz="1400" dirty="0"/>
          </a:p>
        </p:txBody>
      </p:sp>
      <p:sp>
        <p:nvSpPr>
          <p:cNvPr id="52" name="TextBox 51"/>
          <p:cNvSpPr txBox="1"/>
          <p:nvPr/>
        </p:nvSpPr>
        <p:spPr>
          <a:xfrm>
            <a:off x="328152" y="6033743"/>
            <a:ext cx="440100" cy="128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75 </a:t>
            </a:r>
            <a:r>
              <a:rPr lang="en-GB" sz="1400" dirty="0" err="1" smtClean="0"/>
              <a:t>kDa</a:t>
            </a:r>
            <a:r>
              <a:rPr lang="en-GB" sz="1400" dirty="0" smtClean="0"/>
              <a:t> &gt;</a:t>
            </a:r>
            <a:endParaRPr lang="en-GB" sz="1400" dirty="0"/>
          </a:p>
        </p:txBody>
      </p:sp>
      <p:sp>
        <p:nvSpPr>
          <p:cNvPr id="53" name="TextBox 52"/>
          <p:cNvSpPr txBox="1"/>
          <p:nvPr/>
        </p:nvSpPr>
        <p:spPr>
          <a:xfrm>
            <a:off x="328152" y="6236560"/>
            <a:ext cx="440100" cy="128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50 </a:t>
            </a:r>
            <a:r>
              <a:rPr lang="en-GB" sz="1400" dirty="0" err="1" smtClean="0"/>
              <a:t>kDa</a:t>
            </a:r>
            <a:r>
              <a:rPr lang="en-GB" sz="1400" dirty="0" smtClean="0"/>
              <a:t> &gt;</a:t>
            </a:r>
            <a:endParaRPr lang="en-GB" sz="1400" dirty="0"/>
          </a:p>
        </p:txBody>
      </p:sp>
      <p:sp>
        <p:nvSpPr>
          <p:cNvPr id="54" name="TextBox 53"/>
          <p:cNvSpPr txBox="1"/>
          <p:nvPr/>
        </p:nvSpPr>
        <p:spPr>
          <a:xfrm>
            <a:off x="328152" y="6527362"/>
            <a:ext cx="440100" cy="12806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 smtClean="0"/>
              <a:t>25 </a:t>
            </a:r>
            <a:r>
              <a:rPr lang="en-GB" sz="1400" dirty="0" err="1" smtClean="0"/>
              <a:t>kDa</a:t>
            </a:r>
            <a:r>
              <a:rPr lang="en-GB" sz="1400" dirty="0" smtClean="0"/>
              <a:t> &gt;</a:t>
            </a:r>
            <a:endParaRPr lang="en-GB" sz="1400" dirty="0"/>
          </a:p>
        </p:txBody>
      </p:sp>
      <p:sp>
        <p:nvSpPr>
          <p:cNvPr id="55" name="TextBox 54"/>
          <p:cNvSpPr txBox="1"/>
          <p:nvPr/>
        </p:nvSpPr>
        <p:spPr>
          <a:xfrm rot="16200000">
            <a:off x="832981" y="4782710"/>
            <a:ext cx="1388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Marker Lane</a:t>
            </a:r>
            <a:endParaRPr lang="en-GB" dirty="0"/>
          </a:p>
        </p:txBody>
      </p:sp>
      <p:sp>
        <p:nvSpPr>
          <p:cNvPr id="56" name="TextBox 55"/>
          <p:cNvSpPr txBox="1"/>
          <p:nvPr/>
        </p:nvSpPr>
        <p:spPr>
          <a:xfrm rot="16200000">
            <a:off x="2736924" y="4782710"/>
            <a:ext cx="13884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Marker Lane</a:t>
            </a:r>
            <a:endParaRPr lang="en-GB" dirty="0"/>
          </a:p>
        </p:txBody>
      </p:sp>
      <p:cxnSp>
        <p:nvCxnSpPr>
          <p:cNvPr id="57" name="Straight Connector 56"/>
          <p:cNvCxnSpPr/>
          <p:nvPr/>
        </p:nvCxnSpPr>
        <p:spPr>
          <a:xfrm>
            <a:off x="1777938" y="4755616"/>
            <a:ext cx="13001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3615744" y="4763349"/>
            <a:ext cx="130018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5442876" y="5866447"/>
            <a:ext cx="388242" cy="153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HIF1a</a:t>
            </a:r>
            <a:endParaRPr lang="en-GB" dirty="0"/>
          </a:p>
        </p:txBody>
      </p:sp>
      <p:sp>
        <p:nvSpPr>
          <p:cNvPr id="60" name="TextBox 59"/>
          <p:cNvSpPr txBox="1"/>
          <p:nvPr/>
        </p:nvSpPr>
        <p:spPr>
          <a:xfrm>
            <a:off x="5442876" y="6314965"/>
            <a:ext cx="472149" cy="1536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Tubulin</a:t>
            </a:r>
            <a:endParaRPr lang="en-GB" dirty="0"/>
          </a:p>
        </p:txBody>
      </p:sp>
      <p:sp>
        <p:nvSpPr>
          <p:cNvPr id="61" name="TextBox 60"/>
          <p:cNvSpPr txBox="1"/>
          <p:nvPr/>
        </p:nvSpPr>
        <p:spPr>
          <a:xfrm>
            <a:off x="2045966" y="4414821"/>
            <a:ext cx="840100" cy="3714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MCF7</a:t>
            </a:r>
            <a:endParaRPr lang="en-GB" dirty="0"/>
          </a:p>
        </p:txBody>
      </p:sp>
      <p:sp>
        <p:nvSpPr>
          <p:cNvPr id="62" name="TextBox 61"/>
          <p:cNvSpPr txBox="1"/>
          <p:nvPr/>
        </p:nvSpPr>
        <p:spPr>
          <a:xfrm>
            <a:off x="4100286" y="4431465"/>
            <a:ext cx="6574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3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366948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356</Words>
  <Application>Microsoft Office PowerPoint</Application>
  <PresentationFormat>A4 Paper (210x297 mm)</PresentationFormat>
  <Paragraphs>76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nahH</dc:creator>
  <cp:lastModifiedBy>HannahH</cp:lastModifiedBy>
  <cp:revision>8</cp:revision>
  <dcterms:created xsi:type="dcterms:W3CDTF">2017-11-13T08:56:14Z</dcterms:created>
  <dcterms:modified xsi:type="dcterms:W3CDTF">2018-05-09T07:09:55Z</dcterms:modified>
</cp:coreProperties>
</file>